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03" autoAdjust="0"/>
    <p:restoredTop sz="84201" autoAdjust="0"/>
  </p:normalViewPr>
  <p:slideViewPr>
    <p:cSldViewPr showGuides="1">
      <p:cViewPr varScale="1">
        <p:scale>
          <a:sx n="63" d="100"/>
          <a:sy n="63" d="100"/>
        </p:scale>
        <p:origin x="157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6" d="100"/>
          <a:sy n="56" d="100"/>
        </p:scale>
        <p:origin x="-2838" y="-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8299C3-85CB-4B96-BE2A-FC38DD84F6C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BEC852-1F2F-44A1-9319-70860259F4A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635909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244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46372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85408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15451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42347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7847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65097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17725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92021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791422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36384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934F0-84B6-4783-B7DB-27D796C75A3F}" type="datetimeFigureOut">
              <a:rPr lang="en-IE" smtClean="0"/>
              <a:t>31/08/2020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A093E-AB25-42C7-97ED-0D4324E5A75F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08531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IE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8288" y="2024063"/>
            <a:ext cx="3527425" cy="3240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876256" y="1124744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err="1" smtClean="0"/>
              <a:t>Suppl</a:t>
            </a:r>
            <a:r>
              <a:rPr lang="en-IE" dirty="0" smtClean="0"/>
              <a:t> Fig 1</a:t>
            </a:r>
            <a:endParaRPr lang="en-IE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3717429" y="2622178"/>
            <a:ext cx="2150715" cy="156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703966" y="23488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/>
              <a:t>*</a:t>
            </a:r>
            <a:endParaRPr lang="en-IE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5868144" y="2636912"/>
            <a:ext cx="0" cy="14401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707904" y="2628528"/>
            <a:ext cx="0" cy="14401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1386056" y="5278884"/>
            <a:ext cx="685835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I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: MTT assay. </a:t>
            </a:r>
            <a:r>
              <a:rPr lang="en-I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Quantitative analysis of cell viability in untreated and treated SKGT-4 cells (PMA, cocktail 100 </a:t>
            </a:r>
            <a:r>
              <a:rPr lang="en-I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M</a:t>
            </a:r>
            <a:r>
              <a:rPr lang="en-I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DCA 20 </a:t>
            </a:r>
            <a:r>
              <a:rPr lang="en-I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M</a:t>
            </a:r>
            <a:r>
              <a:rPr lang="en-I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DCA 200 </a:t>
            </a:r>
            <a:r>
              <a:rPr lang="en-I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M</a:t>
            </a:r>
            <a:r>
              <a:rPr lang="en-I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6514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74</TotalTime>
  <Words>3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e</dc:creator>
  <cp:lastModifiedBy>Administrator</cp:lastModifiedBy>
  <cp:revision>128</cp:revision>
  <dcterms:created xsi:type="dcterms:W3CDTF">2014-03-27T12:30:02Z</dcterms:created>
  <dcterms:modified xsi:type="dcterms:W3CDTF">2020-08-31T12:40:08Z</dcterms:modified>
</cp:coreProperties>
</file>